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4319588" cy="251936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146479-A359-48F7-BBFA-CEC65D52530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16000" y="101520"/>
            <a:ext cx="3889440" cy="41904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ctr">
            <a:noAutofit/>
          </a:bodyPr>
          <a:p>
            <a:pPr indent="0" algn="ctr">
              <a:buNone/>
              <a:tabLst>
                <a:tab algn="l" pos="0"/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16000" y="587160"/>
            <a:ext cx="3889440" cy="79416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16000" y="1457280"/>
            <a:ext cx="3889440" cy="79416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9D04C1-D01A-4F0A-88D4-A07637D8193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16000" y="101520"/>
            <a:ext cx="3889440" cy="41904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ctr">
            <a:noAutofit/>
          </a:bodyPr>
          <a:p>
            <a:pPr indent="0" algn="ctr">
              <a:buNone/>
              <a:tabLst>
                <a:tab algn="l" pos="0"/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16000" y="587160"/>
            <a:ext cx="1897920" cy="79416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209320" y="587160"/>
            <a:ext cx="1897920" cy="79416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16000" y="1457280"/>
            <a:ext cx="1897920" cy="79416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209320" y="1457280"/>
            <a:ext cx="1897920" cy="79416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5A6C86-1462-48CF-9C74-3D3A9EF50AA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16000" y="101520"/>
            <a:ext cx="3889440" cy="41904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ctr">
            <a:noAutofit/>
          </a:bodyPr>
          <a:p>
            <a:pPr indent="0" algn="ctr">
              <a:buNone/>
              <a:tabLst>
                <a:tab algn="l" pos="0"/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16000" y="587160"/>
            <a:ext cx="1252080" cy="79416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531080" y="587160"/>
            <a:ext cx="1252080" cy="79416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2846160" y="587160"/>
            <a:ext cx="1252080" cy="79416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16000" y="1457280"/>
            <a:ext cx="1252080" cy="79416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531080" y="1457280"/>
            <a:ext cx="1252080" cy="79416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2846160" y="1457280"/>
            <a:ext cx="1252080" cy="79416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4797A3-4241-4E21-AF27-428DDD9B9EA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16000" y="101520"/>
            <a:ext cx="3889440" cy="41904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ctr">
            <a:noAutofit/>
          </a:bodyPr>
          <a:p>
            <a:pPr indent="0" algn="ctr">
              <a:buNone/>
              <a:tabLst>
                <a:tab algn="l" pos="0"/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16000" y="587160"/>
            <a:ext cx="3889440" cy="16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349"/>
              </a:spcBef>
              <a:buNone/>
              <a:tabLst>
                <a:tab algn="l" pos="0"/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58C62A-F6B1-4EE0-AD95-5E166A33B0D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16000" y="101520"/>
            <a:ext cx="3889440" cy="41904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ctr">
            <a:noAutofit/>
          </a:bodyPr>
          <a:p>
            <a:pPr indent="0" algn="ctr">
              <a:buNone/>
              <a:tabLst>
                <a:tab algn="l" pos="0"/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16000" y="587160"/>
            <a:ext cx="3889440" cy="166500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D3ADC7-4020-4E7B-9A30-095FB04B121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16000" y="101520"/>
            <a:ext cx="3889440" cy="41904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ctr">
            <a:noAutofit/>
          </a:bodyPr>
          <a:p>
            <a:pPr indent="0" algn="ctr">
              <a:buNone/>
              <a:tabLst>
                <a:tab algn="l" pos="0"/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16000" y="587160"/>
            <a:ext cx="1897920" cy="166500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209320" y="587160"/>
            <a:ext cx="1897920" cy="166500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DBBF70-7EED-4B5E-803A-748422C3B5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16000" y="101520"/>
            <a:ext cx="3889440" cy="41904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ctr">
            <a:noAutofit/>
          </a:bodyPr>
          <a:p>
            <a:pPr indent="0" algn="ctr">
              <a:buNone/>
              <a:tabLst>
                <a:tab algn="l" pos="0"/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21F281-0B4F-4A76-A774-6E54C4E1FF4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16000" y="101520"/>
            <a:ext cx="3889440" cy="1943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349"/>
              </a:spcBef>
              <a:tabLst>
                <a:tab algn="l" pos="0"/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AC74D4-E64D-4DF2-A2D5-A4D0EFF0A7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16000" y="101520"/>
            <a:ext cx="3889440" cy="41904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ctr">
            <a:noAutofit/>
          </a:bodyPr>
          <a:p>
            <a:pPr indent="0" algn="ctr">
              <a:buNone/>
              <a:tabLst>
                <a:tab algn="l" pos="0"/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16000" y="587160"/>
            <a:ext cx="1897920" cy="79416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209320" y="587160"/>
            <a:ext cx="1897920" cy="166500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16000" y="1457280"/>
            <a:ext cx="1897920" cy="79416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24AEE7-3614-4267-AE71-08EA89F614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16000" y="101520"/>
            <a:ext cx="3889440" cy="41904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ctr">
            <a:noAutofit/>
          </a:bodyPr>
          <a:p>
            <a:pPr indent="0" algn="ctr">
              <a:buNone/>
              <a:tabLst>
                <a:tab algn="l" pos="0"/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16000" y="587160"/>
            <a:ext cx="1897920" cy="166500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209320" y="587160"/>
            <a:ext cx="1897920" cy="79416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209320" y="1457280"/>
            <a:ext cx="1897920" cy="79416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876A2A-0064-4D4B-AF77-15C7EFF671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16000" y="101520"/>
            <a:ext cx="3889440" cy="41904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ctr">
            <a:noAutofit/>
          </a:bodyPr>
          <a:p>
            <a:pPr indent="0" algn="ctr">
              <a:buNone/>
              <a:tabLst>
                <a:tab algn="l" pos="0"/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16000" y="587160"/>
            <a:ext cx="1897920" cy="79416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209320" y="587160"/>
            <a:ext cx="1897920" cy="79416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16000" y="1457280"/>
            <a:ext cx="3889440" cy="79416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t">
            <a:normAutofit/>
          </a:bodyPr>
          <a:p>
            <a:pPr indent="0">
              <a:spcBef>
                <a:spcPts val="349"/>
              </a:spcBef>
              <a:buNone/>
              <a:tabLst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3AA238-F228-48F0-B08E-28E195F502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16000" y="101520"/>
            <a:ext cx="3889440" cy="41904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ctr">
            <a:noAutofit/>
          </a:bodyPr>
          <a:p>
            <a:pPr indent="0" algn="ctr">
              <a:buNone/>
              <a:tabLst>
                <a:tab algn="l" pos="0"/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16000" y="587160"/>
            <a:ext cx="3889440" cy="166500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t">
            <a:normAutofit fontScale="92000"/>
          </a:bodyPr>
          <a:p>
            <a:pPr marL="134280" indent="-134280">
              <a:spcBef>
                <a:spcPts val="349"/>
              </a:spcBef>
              <a:buClr>
                <a:srgbClr val="000000"/>
              </a:buClr>
              <a:buFont typeface="Arial"/>
              <a:buChar char="•"/>
              <a:tabLst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lvl="1" marL="291960" indent="-112320">
              <a:spcBef>
                <a:spcPts val="349"/>
              </a:spcBef>
              <a:buClr>
                <a:srgbClr val="000000"/>
              </a:buClr>
              <a:buFont typeface="Arial"/>
              <a:buChar char="–"/>
              <a:tabLst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lvl="2" marL="449640" indent="-90360">
              <a:spcBef>
                <a:spcPts val="349"/>
              </a:spcBef>
              <a:buClr>
                <a:srgbClr val="000000"/>
              </a:buClr>
              <a:buFont typeface="Arial"/>
              <a:buChar char="•"/>
              <a:tabLst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lvl="3" marL="629280" indent="-90720">
              <a:spcBef>
                <a:spcPts val="349"/>
              </a:spcBef>
              <a:buClr>
                <a:srgbClr val="000000"/>
              </a:buClr>
              <a:buFont typeface="Arial"/>
              <a:buChar char="–"/>
              <a:tabLst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lvl="4" marL="808920" indent="-88920">
              <a:spcBef>
                <a:spcPts val="349"/>
              </a:spcBef>
              <a:buClr>
                <a:srgbClr val="000000"/>
              </a:buClr>
              <a:buFont typeface="Arial"/>
              <a:buChar char="»"/>
              <a:tabLst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lvl="5" marL="808920" indent="-88920">
              <a:spcBef>
                <a:spcPts val="349"/>
              </a:spcBef>
              <a:buClr>
                <a:srgbClr val="000000"/>
              </a:buClr>
              <a:buFont typeface="Arial"/>
              <a:buChar char="»"/>
              <a:tabLst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lvl="6" marL="808920" indent="-88920">
              <a:spcBef>
                <a:spcPts val="349"/>
              </a:spcBef>
              <a:buClr>
                <a:srgbClr val="000000"/>
              </a:buClr>
              <a:buFont typeface="Arial"/>
              <a:buChar char="»"/>
              <a:tabLst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16000" y="2295360"/>
            <a:ext cx="1009440" cy="17496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t">
            <a:noAutofit/>
          </a:bodyPr>
          <a:lstStyle>
            <a:lvl1pPr indent="0">
              <a:buNone/>
              <a:tabLst>
                <a:tab algn="l" pos="0"/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  <a:defRPr b="0" lang="en-US" sz="6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476000" y="2295360"/>
            <a:ext cx="1368360" cy="17496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t">
            <a:noAutofit/>
          </a:bodyPr>
          <a:lstStyle>
            <a:lvl1pPr indent="0" algn="ctr">
              <a:buNone/>
              <a:tabLst>
                <a:tab algn="l" pos="0"/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  <a:defRPr b="0" lang="en-US" sz="6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095280" y="2295360"/>
            <a:ext cx="1009800" cy="174960"/>
          </a:xfrm>
          <a:prstGeom prst="rect">
            <a:avLst/>
          </a:prstGeom>
          <a:noFill/>
          <a:ln w="0">
            <a:noFill/>
          </a:ln>
        </p:spPr>
        <p:txBody>
          <a:bodyPr lIns="39240" rIns="39240" tIns="19440" bIns="19440" anchor="t">
            <a:noAutofit/>
          </a:bodyPr>
          <a:lstStyle>
            <a:lvl1pPr indent="0" algn="r">
              <a:buNone/>
              <a:tabLst>
                <a:tab algn="l" pos="0"/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  <a:defRPr b="0" lang="en-US" sz="6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390600"/>
                <a:tab algn="l" pos="781200"/>
                <a:tab algn="l" pos="1171440"/>
                <a:tab algn="l" pos="1562040"/>
                <a:tab algn="l" pos="1952640"/>
                <a:tab algn="l" pos="2343240"/>
                <a:tab algn="l" pos="2733840"/>
                <a:tab algn="l" pos="3124080"/>
                <a:tab algn="l" pos="3514680"/>
                <a:tab algn="l" pos="3905280"/>
                <a:tab algn="l" pos="4295880"/>
                <a:tab algn="l" pos="4686480"/>
                <a:tab algn="l" pos="5076720"/>
                <a:tab algn="l" pos="5467320"/>
                <a:tab algn="l" pos="5857920"/>
                <a:tab algn="l" pos="6248520"/>
                <a:tab algn="l" pos="6638760"/>
                <a:tab algn="l" pos="7029360"/>
                <a:tab algn="l" pos="7419960"/>
                <a:tab algn="l" pos="7810560"/>
              </a:tabLst>
            </a:pPr>
            <a:fld id="{12C5D7EB-600B-4CF8-B6AD-D731160C22DB}" type="slidenum">
              <a:rPr b="0" lang="en-US" sz="6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16000" y="252360"/>
            <a:ext cx="5545080" cy="2161800"/>
            <a:chOff x="216000" y="252360"/>
            <a:chExt cx="5545080" cy="2161800"/>
          </a:xfrm>
        </p:grpSpPr>
        <p:grpSp>
          <p:nvGrpSpPr>
            <p:cNvPr id="42" name=""/>
            <p:cNvGrpSpPr/>
            <p:nvPr/>
          </p:nvGrpSpPr>
          <p:grpSpPr>
            <a:xfrm>
              <a:off x="216000" y="252360"/>
              <a:ext cx="3974760" cy="1121400"/>
              <a:chOff x="216000" y="252360"/>
              <a:chExt cx="3974760" cy="1121400"/>
            </a:xfrm>
          </p:grpSpPr>
          <p:sp>
            <p:nvSpPr>
              <p:cNvPr id="43" name=""/>
              <p:cNvSpPr/>
              <p:nvPr/>
            </p:nvSpPr>
            <p:spPr>
              <a:xfrm>
                <a:off x="487440" y="632160"/>
                <a:ext cx="572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" name=""/>
              <p:cNvSpPr/>
              <p:nvPr/>
            </p:nvSpPr>
            <p:spPr>
              <a:xfrm>
                <a:off x="487440" y="871560"/>
                <a:ext cx="572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252360" y="479880"/>
                <a:ext cx="441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3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271440" y="721800"/>
                <a:ext cx="441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2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216000" y="265320"/>
                <a:ext cx="514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kD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2161080" y="1158120"/>
                <a:ext cx="2858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2224800" y="969840"/>
                <a:ext cx="2858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3815640" y="985680"/>
                <a:ext cx="375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474840" y="969840"/>
                <a:ext cx="2854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2073960" y="974520"/>
                <a:ext cx="346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aphicFrame>
            <p:nvGraphicFramePr>
              <p:cNvPr id="53" name=""/>
              <p:cNvGraphicFramePr/>
              <p:nvPr/>
            </p:nvGraphicFramePr>
            <p:xfrm>
              <a:off x="562320" y="265320"/>
              <a:ext cx="1708560" cy="675360"/>
            </p:xfrm>
            <a:graphic>
              <a:graphicData uri="http://schemas.openxmlformats.org/presentationml/2006/ole">
                <p:oleObj r:id="rId1" spid="">
                  <p:embed/>
                  <p:pic>
                    <p:nvPicPr>
                      <p:cNvPr id="54" name="" descr=""/>
                      <p:cNvPicPr/>
                      <p:nvPr/>
                    </p:nvPicPr>
                    <p:blipFill>
                      <a:blip r:embed="rId2"/>
                      <a:stretch/>
                    </p:blipFill>
                    <p:spPr>
                      <a:xfrm>
                        <a:off x="562320" y="265320"/>
                        <a:ext cx="1708560" cy="675360"/>
                      </a:xfrm>
                      <a:prstGeom prst="rect">
                        <a:avLst/>
                      </a:prstGeom>
                      <a:ln w="12600">
                        <a:solidFill>
                          <a:srgbClr val="000000"/>
                        </a:solidFill>
                        <a:miter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55" name=""/>
              <p:cNvGraphicFramePr/>
              <p:nvPr/>
            </p:nvGraphicFramePr>
            <p:xfrm>
              <a:off x="2308680" y="252360"/>
              <a:ext cx="1743480" cy="693360"/>
            </p:xfrm>
            <a:graphic>
              <a:graphicData uri="http://schemas.openxmlformats.org/presentationml/2006/ole">
                <p:oleObj r:id="rId3" spid="">
                  <p:embed/>
                  <p:pic>
                    <p:nvPicPr>
                      <p:cNvPr id="56" name="" descr=""/>
                      <p:cNvPicPr/>
                      <p:nvPr/>
                    </p:nvPicPr>
                    <p:blipFill>
                      <a:blip r:embed="rId4"/>
                      <a:stretch/>
                    </p:blipFill>
                    <p:spPr>
                      <a:xfrm>
                        <a:off x="2308680" y="252360"/>
                        <a:ext cx="1743480" cy="693360"/>
                      </a:xfrm>
                      <a:prstGeom prst="rect">
                        <a:avLst/>
                      </a:prstGeom>
                      <a:ln w="9360">
                        <a:solidFill>
                          <a:srgbClr val="000000"/>
                        </a:solidFill>
                        <a:miter/>
                      </a:ln>
                    </p:spPr>
                  </p:pic>
                </p:oleObj>
              </a:graphicData>
            </a:graphic>
          </p:graphicFrame>
          <p:sp>
            <p:nvSpPr>
              <p:cNvPr id="57" name=""/>
              <p:cNvSpPr/>
              <p:nvPr/>
            </p:nvSpPr>
            <p:spPr>
              <a:xfrm flipH="1">
                <a:off x="3246480" y="587520"/>
                <a:ext cx="114480" cy="536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3300840" y="415440"/>
                <a:ext cx="351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9" name=""/>
            <p:cNvSpPr/>
            <p:nvPr/>
          </p:nvSpPr>
          <p:spPr>
            <a:xfrm>
              <a:off x="568440" y="2198520"/>
              <a:ext cx="4876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904.99    1905.04  GAAASPTFLLYLSQNKPK             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350640" y="1859040"/>
              <a:ext cx="5410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Spot  Mr(expt)  Mr(calc)            Peptides                 p    proteins matched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350640" y="2081160"/>
              <a:ext cx="5334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      1482.72    1482.77        LGDTFVLTLSDFR       &lt;0.05     human CD8</a:t>
              </a: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368280" y="2063880"/>
              <a:ext cx="3733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512640" y="1620720"/>
              <a:ext cx="1224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Peptide fragments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2-11T17:26:40Z</dcterms:created>
  <dc:creator>Derrick Gibbings</dc:creator>
  <dc:description/>
  <dc:language>en-US</dc:language>
  <cp:lastModifiedBy>Derrick</cp:lastModifiedBy>
  <dcterms:modified xsi:type="dcterms:W3CDTF">2007-06-16T18:54:48Z</dcterms:modified>
  <cp:revision>4</cp:revision>
  <dc:subject/>
  <dc:title>Slide 1</dc:title>
</cp:coreProperties>
</file>